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78BDD2-117D-4111-A06F-F2F8B1137D45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5388" y="692150"/>
            <a:ext cx="4619625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387136"/>
            <a:ext cx="5608320" cy="41562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9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E0C4B1-694F-49A2-8A07-3F7A7FA048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784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00200" y="926068"/>
            <a:ext cx="6248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S1 </a:t>
            </a:r>
            <a:r>
              <a:rPr lang="en-US" sz="1600" b="1" dirty="0" smtClean="0"/>
              <a:t>Table. </a:t>
            </a:r>
            <a:r>
              <a:rPr lang="en-US" sz="1600" b="1" dirty="0" smtClean="0"/>
              <a:t>Antibodies used for </a:t>
            </a:r>
            <a:r>
              <a:rPr lang="en-US" sz="1600" b="1" dirty="0" err="1" smtClean="0"/>
              <a:t>ChIP</a:t>
            </a:r>
            <a:r>
              <a:rPr lang="en-US" sz="1600" b="1" dirty="0" smtClean="0"/>
              <a:t> and Western blotting</a:t>
            </a:r>
            <a:endParaRPr lang="en-US" sz="1600" b="1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3921934"/>
              </p:ext>
            </p:extLst>
          </p:nvPr>
        </p:nvGraphicFramePr>
        <p:xfrm>
          <a:off x="2209800" y="1397000"/>
          <a:ext cx="5029200" cy="4297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76500"/>
                <a:gridCol w="255270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ntibody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ource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 gridSpan="2">
                  <a:txBody>
                    <a:bodyPr/>
                    <a:lstStyle/>
                    <a:p>
                      <a:pPr algn="ctr"/>
                      <a:r>
                        <a:rPr lang="en-US" sz="1400" b="1" baseline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hIP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kern="1200" dirty="0" smtClean="0">
                        <a:solidFill>
                          <a:schemeClr val="dk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nti-KLF1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 err="1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bcam</a:t>
                      </a:r>
                      <a:r>
                        <a:rPr lang="en-US" sz="14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, ab248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nti-</a:t>
                      </a:r>
                      <a:r>
                        <a:rPr lang="en-US" sz="14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istone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3 (Acetyl K9)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bcam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, ab4441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nti-</a:t>
                      </a:r>
                      <a:r>
                        <a:rPr lang="en-US" sz="14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trimethyl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en-US" sz="14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istone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3</a:t>
                      </a:r>
                      <a:r>
                        <a:rPr lang="en-US" sz="14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(Lys4)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Upstate Millipore, 07-473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nti-RNA polymerase II</a:t>
                      </a:r>
                      <a:r>
                        <a:rPr lang="en-US" sz="14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TD repeat</a:t>
                      </a:r>
                      <a:endParaRPr lang="en-US" sz="1400" dirty="0" smtClean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bcam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, ab26721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nti-RNA polymerase II</a:t>
                      </a:r>
                      <a:r>
                        <a:rPr lang="en-US" sz="14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TD repeat (</a:t>
                      </a:r>
                      <a:r>
                        <a:rPr lang="en-US" sz="1400" baseline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hospho</a:t>
                      </a:r>
                      <a:r>
                        <a:rPr lang="en-US" sz="14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S2)</a:t>
                      </a:r>
                      <a:endParaRPr lang="en-US" sz="1400" dirty="0" smtClean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bcam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, ab509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 grid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Wester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dirty="0" smtClean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nti-KLF1 (F-20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anta Cruz Biotechnology, sc-2719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nti-</a:t>
                      </a:r>
                      <a:r>
                        <a:rPr lang="el-GR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β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en-US" sz="14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Actin</a:t>
                      </a:r>
                      <a:endParaRPr lang="en-US" sz="1400" dirty="0" smtClean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igma, A222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2</TotalTime>
  <Words>71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ivya</dc:creator>
  <cp:lastModifiedBy>Joyce Lloyd</cp:lastModifiedBy>
  <cp:revision>57</cp:revision>
  <cp:lastPrinted>2015-03-09T21:18:51Z</cp:lastPrinted>
  <dcterms:created xsi:type="dcterms:W3CDTF">2015-02-26T10:41:02Z</dcterms:created>
  <dcterms:modified xsi:type="dcterms:W3CDTF">2016-01-07T19:44:26Z</dcterms:modified>
</cp:coreProperties>
</file>